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 autoCompressPictures="0">
  <p:sldMasterIdLst>
    <p:sldMasterId id="2147483660" r:id="rId1"/>
  </p:sldMasterIdLst>
  <p:notesMasterIdLst>
    <p:notesMasterId r:id="rId3"/>
  </p:notesMasterIdLst>
  <p:sldIdLst>
    <p:sldId id="261" r:id="rId2"/>
  </p:sldIdLst>
  <p:sldSz cx="6858000" cy="9907588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68DBF29-173B-1EE4-E980-EBF86C79181A}" name="Editor" initials="SPG" userId="Editor" providerId="Non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2" name="作成者" initials="A" lastIdx="2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436"/>
    <p:restoredTop sz="95144"/>
  </p:normalViewPr>
  <p:slideViewPr>
    <p:cSldViewPr snapToGrid="0" snapToObjects="1">
      <p:cViewPr varScale="1">
        <p:scale>
          <a:sx n="76" d="100"/>
          <a:sy n="76" d="100"/>
        </p:scale>
        <p:origin x="323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FA1680-472E-A346-AB05-63E8C656E06C}" type="datetimeFigureOut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077886-8178-6345-AAD5-1D45D2C4F4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82078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451"/>
            <a:ext cx="5829300" cy="34493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3778"/>
            <a:ext cx="5143500" cy="239204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80BC7-DC1E-474D-AE99-FBB6063509E1}" type="datetimeFigureOut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060FE-C47D-4648-A3EC-3B2B29B924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037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80BC7-DC1E-474D-AE99-FBB6063509E1}" type="datetimeFigureOut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060FE-C47D-4648-A3EC-3B2B29B924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2732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87"/>
            <a:ext cx="1478756" cy="8396223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87"/>
            <a:ext cx="4350544" cy="8396223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80BC7-DC1E-474D-AE99-FBB6063509E1}" type="datetimeFigureOut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060FE-C47D-4648-A3EC-3B2B29B924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684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80BC7-DC1E-474D-AE99-FBB6063509E1}" type="datetimeFigureOut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060FE-C47D-4648-A3EC-3B2B29B924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9624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70019"/>
            <a:ext cx="5915025" cy="4121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30289"/>
            <a:ext cx="5915025" cy="216728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80BC7-DC1E-474D-AE99-FBB6063509E1}" type="datetimeFigureOut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060FE-C47D-4648-A3EC-3B2B29B924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8580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436"/>
            <a:ext cx="2914650" cy="628627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436"/>
            <a:ext cx="2914650" cy="628627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80BC7-DC1E-474D-AE99-FBB6063509E1}" type="datetimeFigureOut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060FE-C47D-4648-A3EC-3B2B29B924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1803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90"/>
            <a:ext cx="5915025" cy="191500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736"/>
            <a:ext cx="2901255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9022"/>
            <a:ext cx="2901255" cy="532303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736"/>
            <a:ext cx="2915543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9022"/>
            <a:ext cx="2915543" cy="532303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80BC7-DC1E-474D-AE99-FBB6063509E1}" type="datetimeFigureOut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060FE-C47D-4648-A3EC-3B2B29B924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81010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80BC7-DC1E-474D-AE99-FBB6063509E1}" type="datetimeFigureOut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060FE-C47D-4648-A3EC-3B2B29B924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5153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80BC7-DC1E-474D-AE99-FBB6063509E1}" type="datetimeFigureOut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060FE-C47D-4648-A3EC-3B2B29B924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09699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511"/>
            <a:ext cx="3471863" cy="704080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80BC7-DC1E-474D-AE99-FBB6063509E1}" type="datetimeFigureOut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060FE-C47D-4648-A3EC-3B2B29B924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6153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511"/>
            <a:ext cx="3471863" cy="704080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80BC7-DC1E-474D-AE99-FBB6063509E1}" type="datetimeFigureOut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060FE-C47D-4648-A3EC-3B2B29B924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263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436"/>
            <a:ext cx="591502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080BC7-DC1E-474D-AE99-FBB6063509E1}" type="datetimeFigureOut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869"/>
            <a:ext cx="231457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E060FE-C47D-4648-A3EC-3B2B29B924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1878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png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図 62">
            <a:extLst>
              <a:ext uri="{FF2B5EF4-FFF2-40B4-BE49-F238E27FC236}">
                <a16:creationId xmlns:a16="http://schemas.microsoft.com/office/drawing/2014/main" id="{4AAC9060-F10D-204F-B434-FEC9291A2085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10800000">
            <a:off x="339831" y="4657768"/>
            <a:ext cx="1440001" cy="1080001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FD35240F-500B-D44B-8B82-C18DF43DCC8D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9104" y="1242521"/>
            <a:ext cx="1440000" cy="1080001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17D1D954-78DF-7149-8823-E5959C7DF63F}"/>
              </a:ext>
            </a:extLst>
          </p:cNvPr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866139" y="2380937"/>
            <a:ext cx="1440000" cy="108000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BA3DF54E-8292-CC49-8D7F-D34729003DFB}"/>
              </a:ext>
            </a:extLst>
          </p:cNvPr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886835" y="4666832"/>
            <a:ext cx="1440000" cy="1080000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71F842C1-ED59-3B49-AEB1-11F7713B8FBA}"/>
              </a:ext>
            </a:extLst>
          </p:cNvPr>
          <p:cNvPicPr>
            <a:picLocks noChangeAspect="1"/>
          </p:cNvPicPr>
          <p:nvPr/>
        </p:nvPicPr>
        <p:blipFill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866139" y="1242521"/>
            <a:ext cx="1440000" cy="1080000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4F90D9EF-0CFB-B343-A12D-C288FC161E6B}"/>
              </a:ext>
            </a:extLst>
          </p:cNvPr>
          <p:cNvPicPr>
            <a:picLocks noChangeAspect="1"/>
          </p:cNvPicPr>
          <p:nvPr/>
        </p:nvPicPr>
        <p:blipFill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866139" y="3527007"/>
            <a:ext cx="1440000" cy="1080000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0D173246-42E6-AC47-8DD5-9CDFCE650CE8}"/>
              </a:ext>
            </a:extLst>
          </p:cNvPr>
          <p:cNvPicPr>
            <a:picLocks noChangeAspect="1"/>
          </p:cNvPicPr>
          <p:nvPr/>
        </p:nvPicPr>
        <p:blipFill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39831" y="2380938"/>
            <a:ext cx="1440000" cy="1080000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D4A1AB2F-DD01-3C47-9225-DF6FE1BFEF64}"/>
              </a:ext>
            </a:extLst>
          </p:cNvPr>
          <p:cNvPicPr>
            <a:picLocks noChangeAspect="1"/>
          </p:cNvPicPr>
          <p:nvPr/>
        </p:nvPicPr>
        <p:blipFill>
          <a:blip r:embed="rId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39831" y="3519353"/>
            <a:ext cx="1440000" cy="1080000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0B4EEAE-4987-D640-9B5A-97C3C57C536C}"/>
              </a:ext>
            </a:extLst>
          </p:cNvPr>
          <p:cNvSpPr txBox="1"/>
          <p:nvPr/>
        </p:nvSpPr>
        <p:spPr>
          <a:xfrm>
            <a:off x="390180" y="945185"/>
            <a:ext cx="13393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MEFV−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group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8B5C1C24-335F-F04C-8D32-2BCD3402E094}"/>
              </a:ext>
            </a:extLst>
          </p:cNvPr>
          <p:cNvSpPr txBox="1"/>
          <p:nvPr/>
        </p:nvSpPr>
        <p:spPr>
          <a:xfrm>
            <a:off x="1887510" y="945185"/>
            <a:ext cx="13393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MEFV+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group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4F9018C-5BCB-1C4E-943F-7E7CE244D8A9}"/>
              </a:ext>
            </a:extLst>
          </p:cNvPr>
          <p:cNvSpPr txBox="1"/>
          <p:nvPr/>
        </p:nvSpPr>
        <p:spPr>
          <a:xfrm>
            <a:off x="51722" y="706553"/>
            <a:ext cx="4036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9B7DFC96-21D4-D54C-81AF-8374455907EC}"/>
              </a:ext>
            </a:extLst>
          </p:cNvPr>
          <p:cNvSpPr txBox="1"/>
          <p:nvPr/>
        </p:nvSpPr>
        <p:spPr>
          <a:xfrm>
            <a:off x="262253" y="5906208"/>
            <a:ext cx="6288273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1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Expression of interleukin-1β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L-1β)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and IL-18 in biopsy samples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iopsy samples from the Mediterranean fever (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MEFV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 gene mutation-negative group (n=4) and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MEFV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gene mutation-positive group (n=4) were stained with anti-IL-1β (a) or anti-IL-18 (b) antibody. Bar indicates 50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pic>
        <p:nvPicPr>
          <p:cNvPr id="25" name="図 24">
            <a:extLst>
              <a:ext uri="{FF2B5EF4-FFF2-40B4-BE49-F238E27FC236}">
                <a16:creationId xmlns:a16="http://schemas.microsoft.com/office/drawing/2014/main" id="{2D95A964-790F-7441-97F6-81ABE75A87D3}"/>
              </a:ext>
            </a:extLst>
          </p:cNvPr>
          <p:cNvPicPr>
            <a:picLocks noChangeAspect="1"/>
          </p:cNvPicPr>
          <p:nvPr/>
        </p:nvPicPr>
        <p:blipFill>
          <a:blip r:embed="rId10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88279" y="1252960"/>
            <a:ext cx="1440000" cy="1080000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6468A6F5-B06B-F449-B866-977DCFB601BE}"/>
              </a:ext>
            </a:extLst>
          </p:cNvPr>
          <p:cNvPicPr>
            <a:picLocks noChangeAspect="1"/>
          </p:cNvPicPr>
          <p:nvPr/>
        </p:nvPicPr>
        <p:blipFill>
          <a:blip r:embed="rId11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292831" y="1252960"/>
            <a:ext cx="1440000" cy="1080000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4141732B-C23A-E749-9ED8-53D775A13CCF}"/>
              </a:ext>
            </a:extLst>
          </p:cNvPr>
          <p:cNvPicPr>
            <a:picLocks noChangeAspect="1"/>
          </p:cNvPicPr>
          <p:nvPr/>
        </p:nvPicPr>
        <p:blipFill>
          <a:blip r:embed="rId1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88279" y="2387896"/>
            <a:ext cx="1440000" cy="1080000"/>
          </a:xfrm>
          <a:prstGeom prst="rect">
            <a:avLst/>
          </a:prstGeom>
        </p:spPr>
      </p:pic>
      <p:pic>
        <p:nvPicPr>
          <p:cNvPr id="30" name="図 29">
            <a:extLst>
              <a:ext uri="{FF2B5EF4-FFF2-40B4-BE49-F238E27FC236}">
                <a16:creationId xmlns:a16="http://schemas.microsoft.com/office/drawing/2014/main" id="{7DB91664-83CB-9E49-A2C9-1D9831F03556}"/>
              </a:ext>
            </a:extLst>
          </p:cNvPr>
          <p:cNvPicPr>
            <a:picLocks noChangeAspect="1"/>
          </p:cNvPicPr>
          <p:nvPr/>
        </p:nvPicPr>
        <p:blipFill>
          <a:blip r:embed="rId1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292831" y="2387896"/>
            <a:ext cx="1440000" cy="1080001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15DAF1A9-2DD3-6049-BEEE-4397D2A4A217}"/>
              </a:ext>
            </a:extLst>
          </p:cNvPr>
          <p:cNvPicPr>
            <a:picLocks noChangeAspect="1"/>
          </p:cNvPicPr>
          <p:nvPr/>
        </p:nvPicPr>
        <p:blipFill>
          <a:blip r:embed="rId1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292831" y="3522833"/>
            <a:ext cx="1440000" cy="1080000"/>
          </a:xfrm>
          <a:prstGeom prst="rect">
            <a:avLst/>
          </a:prstGeom>
        </p:spPr>
      </p:pic>
      <p:pic>
        <p:nvPicPr>
          <p:cNvPr id="32" name="図 31">
            <a:extLst>
              <a:ext uri="{FF2B5EF4-FFF2-40B4-BE49-F238E27FC236}">
                <a16:creationId xmlns:a16="http://schemas.microsoft.com/office/drawing/2014/main" id="{3B22105D-E9FB-5042-A692-B7CD51C5B993}"/>
              </a:ext>
            </a:extLst>
          </p:cNvPr>
          <p:cNvPicPr>
            <a:picLocks noChangeAspect="1"/>
          </p:cNvPicPr>
          <p:nvPr/>
        </p:nvPicPr>
        <p:blipFill>
          <a:blip r:embed="rId1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292831" y="4657769"/>
            <a:ext cx="1440000" cy="1080000"/>
          </a:xfrm>
          <a:prstGeom prst="rect">
            <a:avLst/>
          </a:prstGeom>
        </p:spPr>
      </p:pic>
      <p:pic>
        <p:nvPicPr>
          <p:cNvPr id="33" name="図 32">
            <a:extLst>
              <a:ext uri="{FF2B5EF4-FFF2-40B4-BE49-F238E27FC236}">
                <a16:creationId xmlns:a16="http://schemas.microsoft.com/office/drawing/2014/main" id="{69BE4A19-418D-8347-87DC-F289C8B05ECD}"/>
              </a:ext>
            </a:extLst>
          </p:cNvPr>
          <p:cNvPicPr>
            <a:picLocks noChangeAspect="1"/>
          </p:cNvPicPr>
          <p:nvPr/>
        </p:nvPicPr>
        <p:blipFill>
          <a:blip r:embed="rId1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88279" y="3522832"/>
            <a:ext cx="1440000" cy="1080000"/>
          </a:xfrm>
          <a:prstGeom prst="rect">
            <a:avLst/>
          </a:prstGeom>
        </p:spPr>
      </p:pic>
      <p:pic>
        <p:nvPicPr>
          <p:cNvPr id="34" name="図 33">
            <a:extLst>
              <a:ext uri="{FF2B5EF4-FFF2-40B4-BE49-F238E27FC236}">
                <a16:creationId xmlns:a16="http://schemas.microsoft.com/office/drawing/2014/main" id="{180D895E-1F9C-014C-A20E-7A2344A79AA9}"/>
              </a:ext>
            </a:extLst>
          </p:cNvPr>
          <p:cNvPicPr>
            <a:picLocks noChangeAspect="1"/>
          </p:cNvPicPr>
          <p:nvPr/>
        </p:nvPicPr>
        <p:blipFill>
          <a:blip r:embed="rId1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88279" y="4657769"/>
            <a:ext cx="1440000" cy="1080000"/>
          </a:xfrm>
          <a:prstGeom prst="rect">
            <a:avLst/>
          </a:prstGeom>
        </p:spPr>
      </p:pic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5D9149CB-24AC-1D4A-9506-C955617BFB51}"/>
              </a:ext>
            </a:extLst>
          </p:cNvPr>
          <p:cNvSpPr txBox="1"/>
          <p:nvPr/>
        </p:nvSpPr>
        <p:spPr>
          <a:xfrm>
            <a:off x="3853470" y="945185"/>
            <a:ext cx="13393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MEFV−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group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3CA8A48F-5287-4344-8245-0C9FC6B6DD41}"/>
              </a:ext>
            </a:extLst>
          </p:cNvPr>
          <p:cNvSpPr txBox="1"/>
          <p:nvPr/>
        </p:nvSpPr>
        <p:spPr>
          <a:xfrm>
            <a:off x="5350800" y="945185"/>
            <a:ext cx="13393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MEFV+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88210F33-E070-3144-98E2-1CFB34087892}"/>
              </a:ext>
            </a:extLst>
          </p:cNvPr>
          <p:cNvSpPr txBox="1"/>
          <p:nvPr/>
        </p:nvSpPr>
        <p:spPr>
          <a:xfrm>
            <a:off x="3449868" y="694521"/>
            <a:ext cx="4553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CB7A7C08-1B92-7140-9CEB-FDE5F497D0A2}"/>
              </a:ext>
            </a:extLst>
          </p:cNvPr>
          <p:cNvSpPr txBox="1"/>
          <p:nvPr/>
        </p:nvSpPr>
        <p:spPr>
          <a:xfrm>
            <a:off x="1255693" y="684605"/>
            <a:ext cx="10842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017F7045-4838-4D43-A013-BB4C15157912}"/>
              </a:ext>
            </a:extLst>
          </p:cNvPr>
          <p:cNvSpPr txBox="1"/>
          <p:nvPr/>
        </p:nvSpPr>
        <p:spPr>
          <a:xfrm>
            <a:off x="4720676" y="696636"/>
            <a:ext cx="10842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L-18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CDC985EB-AA55-7C44-AF90-5E6C8FC695EE}"/>
              </a:ext>
            </a:extLst>
          </p:cNvPr>
          <p:cNvCxnSpPr>
            <a:cxnSpLocks/>
          </p:cNvCxnSpPr>
          <p:nvPr/>
        </p:nvCxnSpPr>
        <p:spPr>
          <a:xfrm>
            <a:off x="1594040" y="2273524"/>
            <a:ext cx="1354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D98EB184-14AE-EB46-8A4A-0BEFBD475CC9}"/>
              </a:ext>
            </a:extLst>
          </p:cNvPr>
          <p:cNvCxnSpPr>
            <a:cxnSpLocks/>
          </p:cNvCxnSpPr>
          <p:nvPr/>
        </p:nvCxnSpPr>
        <p:spPr>
          <a:xfrm>
            <a:off x="3133915" y="2273524"/>
            <a:ext cx="1354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C3D46545-608C-E44A-9459-DB03A59B6313}"/>
              </a:ext>
            </a:extLst>
          </p:cNvPr>
          <p:cNvCxnSpPr>
            <a:cxnSpLocks/>
          </p:cNvCxnSpPr>
          <p:nvPr/>
        </p:nvCxnSpPr>
        <p:spPr>
          <a:xfrm>
            <a:off x="1594040" y="3410174"/>
            <a:ext cx="1354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D383BE95-FD40-2446-BB48-96D4A0DE329E}"/>
              </a:ext>
            </a:extLst>
          </p:cNvPr>
          <p:cNvCxnSpPr>
            <a:cxnSpLocks/>
          </p:cNvCxnSpPr>
          <p:nvPr/>
        </p:nvCxnSpPr>
        <p:spPr>
          <a:xfrm>
            <a:off x="3133915" y="3410174"/>
            <a:ext cx="1354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794930B8-D2FE-8343-99A0-1EBB24F3BFB8}"/>
              </a:ext>
            </a:extLst>
          </p:cNvPr>
          <p:cNvCxnSpPr>
            <a:cxnSpLocks/>
          </p:cNvCxnSpPr>
          <p:nvPr/>
        </p:nvCxnSpPr>
        <p:spPr>
          <a:xfrm>
            <a:off x="1594040" y="4549999"/>
            <a:ext cx="1354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B9D6C601-2BD0-8D49-83EA-A9F712202A38}"/>
              </a:ext>
            </a:extLst>
          </p:cNvPr>
          <p:cNvCxnSpPr>
            <a:cxnSpLocks/>
          </p:cNvCxnSpPr>
          <p:nvPr/>
        </p:nvCxnSpPr>
        <p:spPr>
          <a:xfrm>
            <a:off x="3133915" y="4549999"/>
            <a:ext cx="1354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2C87C066-0BC8-D04D-9078-2EE94BA7BB5E}"/>
              </a:ext>
            </a:extLst>
          </p:cNvPr>
          <p:cNvCxnSpPr>
            <a:cxnSpLocks/>
          </p:cNvCxnSpPr>
          <p:nvPr/>
        </p:nvCxnSpPr>
        <p:spPr>
          <a:xfrm>
            <a:off x="1594040" y="5683474"/>
            <a:ext cx="1354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7EE15033-0E96-D04E-ADF9-D62A3558A24C}"/>
              </a:ext>
            </a:extLst>
          </p:cNvPr>
          <p:cNvCxnSpPr>
            <a:cxnSpLocks/>
          </p:cNvCxnSpPr>
          <p:nvPr/>
        </p:nvCxnSpPr>
        <p:spPr>
          <a:xfrm>
            <a:off x="3133915" y="5683474"/>
            <a:ext cx="1354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869757B1-1379-8248-B0E0-D9742C841EFE}"/>
              </a:ext>
            </a:extLst>
          </p:cNvPr>
          <p:cNvCxnSpPr>
            <a:cxnSpLocks/>
          </p:cNvCxnSpPr>
          <p:nvPr/>
        </p:nvCxnSpPr>
        <p:spPr>
          <a:xfrm>
            <a:off x="5051446" y="2273524"/>
            <a:ext cx="1354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39C58EAF-97AD-3E47-8CCC-7BCCAB4CF315}"/>
              </a:ext>
            </a:extLst>
          </p:cNvPr>
          <p:cNvCxnSpPr>
            <a:cxnSpLocks/>
          </p:cNvCxnSpPr>
          <p:nvPr/>
        </p:nvCxnSpPr>
        <p:spPr>
          <a:xfrm>
            <a:off x="6591321" y="2273524"/>
            <a:ext cx="1354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71DE48D3-E499-D541-8C86-884F3D35F41E}"/>
              </a:ext>
            </a:extLst>
          </p:cNvPr>
          <p:cNvCxnSpPr>
            <a:cxnSpLocks/>
          </p:cNvCxnSpPr>
          <p:nvPr/>
        </p:nvCxnSpPr>
        <p:spPr>
          <a:xfrm>
            <a:off x="5051446" y="3410174"/>
            <a:ext cx="1354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17E23CA8-069B-944F-820C-D864EE664E1E}"/>
              </a:ext>
            </a:extLst>
          </p:cNvPr>
          <p:cNvCxnSpPr>
            <a:cxnSpLocks/>
          </p:cNvCxnSpPr>
          <p:nvPr/>
        </p:nvCxnSpPr>
        <p:spPr>
          <a:xfrm>
            <a:off x="6591321" y="3410174"/>
            <a:ext cx="1354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240062D4-6902-5948-9CB6-122AE6083AE3}"/>
              </a:ext>
            </a:extLst>
          </p:cNvPr>
          <p:cNvCxnSpPr>
            <a:cxnSpLocks/>
          </p:cNvCxnSpPr>
          <p:nvPr/>
        </p:nvCxnSpPr>
        <p:spPr>
          <a:xfrm>
            <a:off x="5051446" y="4549999"/>
            <a:ext cx="1354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4B30421F-122A-684A-8774-CC15E6F356EB}"/>
              </a:ext>
            </a:extLst>
          </p:cNvPr>
          <p:cNvCxnSpPr>
            <a:cxnSpLocks/>
          </p:cNvCxnSpPr>
          <p:nvPr/>
        </p:nvCxnSpPr>
        <p:spPr>
          <a:xfrm>
            <a:off x="6591321" y="4549999"/>
            <a:ext cx="1354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1049C969-277A-7844-A814-CA4FCD748541}"/>
              </a:ext>
            </a:extLst>
          </p:cNvPr>
          <p:cNvCxnSpPr>
            <a:cxnSpLocks/>
          </p:cNvCxnSpPr>
          <p:nvPr/>
        </p:nvCxnSpPr>
        <p:spPr>
          <a:xfrm>
            <a:off x="5051446" y="5683474"/>
            <a:ext cx="1354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EC994965-6B18-3A43-99D6-C053C90D8FB1}"/>
              </a:ext>
            </a:extLst>
          </p:cNvPr>
          <p:cNvCxnSpPr>
            <a:cxnSpLocks/>
          </p:cNvCxnSpPr>
          <p:nvPr/>
        </p:nvCxnSpPr>
        <p:spPr>
          <a:xfrm>
            <a:off x="6591321" y="5683474"/>
            <a:ext cx="1354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473734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1</Words>
  <Application>Microsoft Macintosh PowerPoint</Application>
  <PresentationFormat>ユーザー設定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2-05-06T07:36:14Z</dcterms:created>
  <dcterms:modified xsi:type="dcterms:W3CDTF">2022-06-08T21:20:42Z</dcterms:modified>
</cp:coreProperties>
</file>